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1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B84F35-C955-BD7C-8921-C2A6FA7583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0CC3780-2991-54BD-9CFA-EE6C442761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0A91A1-237F-5D99-BCF1-AFF8B33A2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C5CE41-4B30-86B4-1BD5-B1BAF2FBC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F71B44-1044-E420-537D-DE098BFE5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1587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A75A80-97A1-0261-B8B5-69C81609BB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45E165-45D9-3D22-11A4-88652A6211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36B6DC-7357-7DC3-65C6-C59F2B835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2F5ADF-EB99-3D81-85A0-676928114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364188-AD11-178D-8654-70E3F5845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759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E28C398-D57B-073F-217D-709F5E54F7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91E94C6-F27E-2D70-3347-BE5D02AC3A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6BF32D-F52D-E4D0-BF5F-4187CD4C5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27D96F-B289-4009-726D-4AC0034A0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B92E5F-9D52-CC33-86CD-DB1259BB4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7577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FEAC7B-44AF-514D-66F0-1E483574F8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8BF90CC-33DB-2518-5089-3B2DFB539F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7F72EC-ABF8-8E9C-5050-01A072F7F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65836B-0411-A0B9-B10A-D80AFD21F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0DAFE4-660F-C601-870C-31FF59BCD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9345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7CDC1A-7C14-5D1E-A87B-70516D96D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F744957-678D-B90B-222C-43B4C621C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5729EC-EF9C-E5EC-02E5-61664BAD1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9B7B9E-5CBE-2705-9573-BCA3C182A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997C70-FB02-4C4E-30D8-B5DC003EC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958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546D42-25EC-6373-F2E5-2663DE5EC5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BF3061-339D-758F-3BC0-FEF0908453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E383614-DCBF-51CB-95C4-3C01A8E282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AA5C22E-F291-AF8E-759D-449401959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52E1CCA-CB07-ABA6-D1D1-10D41052C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7BF492-D60E-F6D2-EF3E-A8A9512CA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5736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B85143-86CD-494B-A246-5112F71C2D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30C13C1-39A5-73EA-A25C-CEE8924206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84970E-E086-CF7D-7138-489EF80FE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4FECD27-5292-D339-C3B9-3F6D8A54D5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8CA4A90-B5A8-5593-C4D3-333B90C16D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7E3A862-A501-75A6-F31E-7E4DA82E2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3AF26A6-0F0B-CAF6-5400-7BB8A1A17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486D659-DAB1-ABCB-BF31-5A25F6BB7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8641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1F57D7-EBAB-6E66-8A3D-A8B4247B33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B5AA7A-D600-C060-01E5-6A12EE82C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251262F-3946-B8F7-5FC6-363E30825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1A4CEF6-E073-7085-51BC-0A997056E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56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B837A87-B925-A6D7-5076-06DD5FD7E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84D7E54-C63A-A999-8F8C-A83C50DD0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A755CE-520C-A0A8-D189-CF0192A6E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5887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A869D7-A06F-38AB-D040-0BA2FC2E8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B166CD8-6DD7-CC13-76AD-926E0241E1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878F74-99EF-3BFC-DDF2-46D28A210A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EDF023A-F3A7-FC94-E10D-91CF8A447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02A2E95-971D-F1FB-A008-87EB94BD3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19F5B1-88CB-A469-2B44-79B1DC53E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0025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97DB8C-930D-8664-CA0A-D105FA3C9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23E9B88-E8BB-E6E9-C645-CA88A5A63B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7D2A8BB-1703-18D8-BEA7-3BF12A1ECF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500F84-99FB-BE50-D8B1-393A796ED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878C0EE-D906-C5FD-8FD7-802DCB1BA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15196C6-B056-1472-024B-6F74FA4D5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30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F790CBB-AB74-0B94-F4C3-B862794E6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76E00C-1E60-0BFE-48DB-27E8C64DA3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9F6C4D-CDDD-8860-55B8-E3F385D418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88180E-506C-4D63-B000-BAB6407C1D56}" type="datetimeFigureOut">
              <a:rPr lang="zh-CN" altLang="en-US" smtClean="0"/>
              <a:t>2023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198BBA-839B-35A2-A2AD-274562B609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D1C2E7-58E7-0E27-F559-D09A5C9904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D4F8CF-10F6-4A05-95D7-1BEBD927F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786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9B52010-08A4-0D1C-2F68-A7C1E74D4DCC}"/>
              </a:ext>
            </a:extLst>
          </p:cNvPr>
          <p:cNvSpPr txBox="1"/>
          <p:nvPr/>
        </p:nvSpPr>
        <p:spPr>
          <a:xfrm>
            <a:off x="5641144" y="2968283"/>
            <a:ext cx="914400" cy="914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87BC6F3-CDC9-559D-A6C9-1A1E5B4E238F}"/>
              </a:ext>
            </a:extLst>
          </p:cNvPr>
          <p:cNvSpPr txBox="1"/>
          <p:nvPr/>
        </p:nvSpPr>
        <p:spPr>
          <a:xfrm>
            <a:off x="805960" y="6006904"/>
            <a:ext cx="10944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Correlation diagram of transcriptome samples. The samples were three biological replicates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chardgras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roots at 0, 8, and 24 h of submergence stress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1E773A78-A032-9B17-7129-347C8E4BE0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5806" y="739726"/>
            <a:ext cx="5224975" cy="5224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7407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DF68DB0-0B44-5591-3173-D24DFF3A0B9C}"/>
              </a:ext>
            </a:extLst>
          </p:cNvPr>
          <p:cNvSpPr txBox="1"/>
          <p:nvPr/>
        </p:nvSpPr>
        <p:spPr>
          <a:xfrm>
            <a:off x="698695" y="6010527"/>
            <a:ext cx="1149330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. Statistics of GO annotation classification of differentially expressed genes of 8h vs 0h (A) and 24h vs 0h (B)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chardgras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roots under submergence stress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849D04BE-F272-AECC-FC62-086B9FB009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1582" y="604909"/>
            <a:ext cx="5405618" cy="540561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C710787-DDC5-A8E6-72E6-319607166FF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475" y="604909"/>
            <a:ext cx="5222739" cy="5222739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3AE7F235-FB90-4BD6-9319-4650AFC78245}"/>
              </a:ext>
            </a:extLst>
          </p:cNvPr>
          <p:cNvSpPr txBox="1"/>
          <p:nvPr/>
        </p:nvSpPr>
        <p:spPr>
          <a:xfrm>
            <a:off x="576775" y="717452"/>
            <a:ext cx="546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9302CE2-20A5-77B9-3251-484A99778365}"/>
              </a:ext>
            </a:extLst>
          </p:cNvPr>
          <p:cNvSpPr txBox="1"/>
          <p:nvPr/>
        </p:nvSpPr>
        <p:spPr>
          <a:xfrm>
            <a:off x="6095892" y="748830"/>
            <a:ext cx="546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12999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13684FF-BBDC-C447-359D-D877F3929953}"/>
              </a:ext>
            </a:extLst>
          </p:cNvPr>
          <p:cNvSpPr txBox="1"/>
          <p:nvPr/>
        </p:nvSpPr>
        <p:spPr>
          <a:xfrm>
            <a:off x="243840" y="5934670"/>
            <a:ext cx="1170432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.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PCR validation of 11 randomly selected differentially expressed genes in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chardgras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roots under both 8h and 24h of submergence stress (A). Correlation analysis of qPCR and RNA-Seq at 8h (B) and 24h (C)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3BE35A0-3F93-BD32-E5AD-A8B3DED7B4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379" y="1322363"/>
            <a:ext cx="5892464" cy="348878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EAD4AB7-A974-A141-042A-5FA324217F4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7779" y="3249637"/>
            <a:ext cx="4286539" cy="260874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6C8DBB9-2179-ED5C-3A3A-D10C1D04927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7779" y="301876"/>
            <a:ext cx="4284510" cy="276488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D30533AF-FB31-ABBA-7778-BBCBDCCC98DE}"/>
              </a:ext>
            </a:extLst>
          </p:cNvPr>
          <p:cNvSpPr txBox="1"/>
          <p:nvPr/>
        </p:nvSpPr>
        <p:spPr>
          <a:xfrm>
            <a:off x="243840" y="1007217"/>
            <a:ext cx="8253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7993E52-707C-7F2A-0FD4-1E7F3D3B0CDE}"/>
              </a:ext>
            </a:extLst>
          </p:cNvPr>
          <p:cNvSpPr txBox="1"/>
          <p:nvPr/>
        </p:nvSpPr>
        <p:spPr>
          <a:xfrm>
            <a:off x="6585126" y="61923"/>
            <a:ext cx="8253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ABB191C-626C-41C1-21B1-F35CC19FEDFF}"/>
              </a:ext>
            </a:extLst>
          </p:cNvPr>
          <p:cNvSpPr txBox="1"/>
          <p:nvPr/>
        </p:nvSpPr>
        <p:spPr>
          <a:xfrm>
            <a:off x="6585125" y="3034844"/>
            <a:ext cx="8253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23178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EF4AE1A-4FA1-6237-8C11-58D5CBF86F67}"/>
              </a:ext>
            </a:extLst>
          </p:cNvPr>
          <p:cNvSpPr txBox="1"/>
          <p:nvPr/>
        </p:nvSpPr>
        <p:spPr>
          <a:xfrm>
            <a:off x="3995224" y="6211669"/>
            <a:ext cx="955196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. HMDB classification annotation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EMs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4561EF8-42B8-09A5-D96A-18D137DC29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7886" y="1481517"/>
            <a:ext cx="5516227" cy="45675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26430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7A0E086-BC4C-1A3A-F70B-288F18178277}"/>
              </a:ext>
            </a:extLst>
          </p:cNvPr>
          <p:cNvSpPr txBox="1"/>
          <p:nvPr/>
        </p:nvSpPr>
        <p:spPr>
          <a:xfrm>
            <a:off x="3559127" y="6035431"/>
            <a:ext cx="110290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5. QC sample correlation chart of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EMs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0620F86-ABB8-58F6-5893-C826F95973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1181" y="1001472"/>
            <a:ext cx="5486585" cy="4855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26800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09F7B2C-78B7-1105-F435-B3AA60A6E450}"/>
              </a:ext>
            </a:extLst>
          </p:cNvPr>
          <p:cNvSpPr txBox="1"/>
          <p:nvPr/>
        </p:nvSpPr>
        <p:spPr>
          <a:xfrm>
            <a:off x="2560320" y="5753686"/>
            <a:ext cx="107899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6. PLS-DA analysis of 8h vs 0h (A) and 24h vs 0h (B)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chardgras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roots under submergence stress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C6042AA-8133-9767-CBFF-367939E799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0997" y="1394944"/>
            <a:ext cx="3863989" cy="406495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3089C2A-A45F-5052-36FB-49612083C82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0374" y="1394944"/>
            <a:ext cx="3863989" cy="403002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AC61569-A34F-0D4B-FD30-148D52274BE9}"/>
              </a:ext>
            </a:extLst>
          </p:cNvPr>
          <p:cNvSpPr txBox="1"/>
          <p:nvPr/>
        </p:nvSpPr>
        <p:spPr>
          <a:xfrm>
            <a:off x="1635338" y="1433036"/>
            <a:ext cx="790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C9625C0-B09F-4B3D-89FC-A9D9353F5B43}"/>
              </a:ext>
            </a:extLst>
          </p:cNvPr>
          <p:cNvSpPr txBox="1"/>
          <p:nvPr/>
        </p:nvSpPr>
        <p:spPr>
          <a:xfrm>
            <a:off x="6510997" y="1392832"/>
            <a:ext cx="790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52865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5DF57FD-85BF-4DEC-5727-7C1489EB366B}"/>
              </a:ext>
            </a:extLst>
          </p:cNvPr>
          <p:cNvSpPr txBox="1"/>
          <p:nvPr/>
        </p:nvSpPr>
        <p:spPr>
          <a:xfrm>
            <a:off x="1041008" y="5819559"/>
            <a:ext cx="1194347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7. Correlation analysis of top 20 DEMs with the smallest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value of 8h vs 0h (A) and 24h vs 0h (B)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chardgras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roots under submergence stress.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88805B0-2355-26A3-A27E-C9C068380F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0" y="1076974"/>
            <a:ext cx="3641705" cy="4557137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8B04B63-73A0-15C8-320B-F5F32730B2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2929" y="1038440"/>
            <a:ext cx="3843071" cy="478111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2980E37-749E-86DC-D952-0C80FA5E147D}"/>
              </a:ext>
            </a:extLst>
          </p:cNvPr>
          <p:cNvSpPr txBox="1"/>
          <p:nvPr/>
        </p:nvSpPr>
        <p:spPr>
          <a:xfrm>
            <a:off x="1657916" y="1615439"/>
            <a:ext cx="5205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B60162B-E804-0556-3B80-EFB8B1FA4B3E}"/>
              </a:ext>
            </a:extLst>
          </p:cNvPr>
          <p:cNvSpPr txBox="1"/>
          <p:nvPr/>
        </p:nvSpPr>
        <p:spPr>
          <a:xfrm>
            <a:off x="5910255" y="1615439"/>
            <a:ext cx="5205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72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194</Words>
  <Application>Microsoft Office PowerPoint</Application>
  <PresentationFormat>Widescreen</PresentationFormat>
  <Paragraphs>1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pp1900@outlook.com</dc:creator>
  <cp:lastModifiedBy>Jiang, Yiwei</cp:lastModifiedBy>
  <cp:revision>1</cp:revision>
  <dcterms:created xsi:type="dcterms:W3CDTF">2022-10-29T02:45:59Z</dcterms:created>
  <dcterms:modified xsi:type="dcterms:W3CDTF">2023-01-03T11:30:11Z</dcterms:modified>
</cp:coreProperties>
</file>